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9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27EA7B-7F24-0ABD-6537-DBADD8D8F587}" v="2" dt="2019-10-07T02:34:20.464"/>
    <p1510:client id="{3616BD1D-5CCC-51FB-26E6-EA58CE489414}" v="5" dt="2019-10-07T02:46:09.278"/>
    <p1510:client id="{ABD2D9A6-6AE6-4DAE-7E6E-EB84A508C742}" v="7" dt="2019-10-07T02:31:06.965"/>
    <p1510:client id="{B1227DA5-5ACA-AFBA-7F14-27659559053A}" v="3" dt="2019-09-06T04:20:17.70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498" autoAdjust="0"/>
    <p:restoredTop sz="96834" autoAdjust="0"/>
  </p:normalViewPr>
  <p:slideViewPr>
    <p:cSldViewPr snapToGrid="0">
      <p:cViewPr varScale="1">
        <p:scale>
          <a:sx n="127" d="100"/>
          <a:sy n="127" d="100"/>
        </p:scale>
        <p:origin x="1668" y="1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29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28" Type="http://schemas.microsoft.com/office/2015/10/relationships/revisionInfo" Target="revisionInfo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NKAWA Satoru" userId="S::323329@jp.honda-ri.com::c45c76bf-e864-4554-8776-a99736ef45b7" providerId="AD" clId="Web-{C4105132-E7A9-E907-FE9E-31E6CDF6AA78}"/>
    <pc:docChg chg="modSld">
      <pc:chgData name="SHINKAWA Satoru" userId="S::323329@jp.honda-ri.com::c45c76bf-e864-4554-8776-a99736ef45b7" providerId="AD" clId="Web-{C4105132-E7A9-E907-FE9E-31E6CDF6AA78}" dt="2019-07-17T08:45:33.851" v="7"/>
      <pc:docMkLst>
        <pc:docMk/>
      </pc:docMkLst>
      <pc:sldChg chg="addSp delSp modSp">
        <pc:chgData name="SHINKAWA Satoru" userId="S::323329@jp.honda-ri.com::c45c76bf-e864-4554-8776-a99736ef45b7" providerId="AD" clId="Web-{C4105132-E7A9-E907-FE9E-31E6CDF6AA78}" dt="2019-07-17T08:45:33.851" v="7"/>
        <pc:sldMkLst>
          <pc:docMk/>
          <pc:sldMk cId="2558221072" sldId="257"/>
        </pc:sldMkLst>
        <pc:picChg chg="add del mod">
          <ac:chgData name="SHINKAWA Satoru" userId="S::323329@jp.honda-ri.com::c45c76bf-e864-4554-8776-a99736ef45b7" providerId="AD" clId="Web-{C4105132-E7A9-E907-FE9E-31E6CDF6AA78}" dt="2019-07-17T08:45:23.867" v="3"/>
          <ac:picMkLst>
            <pc:docMk/>
            <pc:sldMk cId="2558221072" sldId="257"/>
            <ac:picMk id="3" creationId="{E6B60ACA-50DC-403D-826E-137E9C695164}"/>
          </ac:picMkLst>
        </pc:picChg>
        <pc:picChg chg="del">
          <ac:chgData name="SHINKAWA Satoru" userId="S::323329@jp.honda-ri.com::c45c76bf-e864-4554-8776-a99736ef45b7" providerId="AD" clId="Web-{C4105132-E7A9-E907-FE9E-31E6CDF6AA78}" dt="2019-07-17T08:45:09.648" v="0"/>
          <ac:picMkLst>
            <pc:docMk/>
            <pc:sldMk cId="2558221072" sldId="257"/>
            <ac:picMk id="4" creationId="{00000000-0000-0000-0000-000000000000}"/>
          </ac:picMkLst>
        </pc:picChg>
        <pc:picChg chg="add del mod">
          <ac:chgData name="SHINKAWA Satoru" userId="S::323329@jp.honda-ri.com::c45c76bf-e864-4554-8776-a99736ef45b7" providerId="AD" clId="Web-{C4105132-E7A9-E907-FE9E-31E6CDF6AA78}" dt="2019-07-17T08:45:27.851" v="5"/>
          <ac:picMkLst>
            <pc:docMk/>
            <pc:sldMk cId="2558221072" sldId="257"/>
            <ac:picMk id="7" creationId="{DA281D69-2AF9-4E9D-87E9-C366A9C56730}"/>
          </ac:picMkLst>
        </pc:picChg>
        <pc:picChg chg="add del mod">
          <ac:chgData name="SHINKAWA Satoru" userId="S::323329@jp.honda-ri.com::c45c76bf-e864-4554-8776-a99736ef45b7" providerId="AD" clId="Web-{C4105132-E7A9-E907-FE9E-31E6CDF6AA78}" dt="2019-07-17T08:45:33.851" v="7"/>
          <ac:picMkLst>
            <pc:docMk/>
            <pc:sldMk cId="2558221072" sldId="257"/>
            <ac:picMk id="12" creationId="{046BD05E-E883-410A-A0F3-37195E958E1C}"/>
          </ac:picMkLst>
        </pc:picChg>
      </pc:sldChg>
    </pc:docChg>
  </pc:docChgLst>
  <pc:docChgLst>
    <pc:chgData name="SHINKAWA Satoru" userId="S::323329@jp.honda-ri.com::c45c76bf-e864-4554-8776-a99736ef45b7" providerId="AD" clId="Web-{3616BD1D-5CCC-51FB-26E6-EA58CE489414}"/>
    <pc:docChg chg="modSld">
      <pc:chgData name="SHINKAWA Satoru" userId="S::323329@jp.honda-ri.com::c45c76bf-e864-4554-8776-a99736ef45b7" providerId="AD" clId="Web-{3616BD1D-5CCC-51FB-26E6-EA58CE489414}" dt="2019-10-07T02:46:09.278" v="4"/>
      <pc:docMkLst>
        <pc:docMk/>
      </pc:docMkLst>
      <pc:sldChg chg="delSp modSp">
        <pc:chgData name="SHINKAWA Satoru" userId="S::323329@jp.honda-ri.com::c45c76bf-e864-4554-8776-a99736ef45b7" providerId="AD" clId="Web-{3616BD1D-5CCC-51FB-26E6-EA58CE489414}" dt="2019-10-07T02:46:09.278" v="4"/>
        <pc:sldMkLst>
          <pc:docMk/>
          <pc:sldMk cId="3602664236" sldId="288"/>
        </pc:sldMkLst>
        <pc:spChg chg="del mod">
          <ac:chgData name="SHINKAWA Satoru" userId="S::323329@jp.honda-ri.com::c45c76bf-e864-4554-8776-a99736ef45b7" providerId="AD" clId="Web-{3616BD1D-5CCC-51FB-26E6-EA58CE489414}" dt="2019-10-07T02:46:09.278" v="4"/>
          <ac:spMkLst>
            <pc:docMk/>
            <pc:sldMk cId="3602664236" sldId="288"/>
            <ac:spMk id="2" creationId="{00000000-0000-0000-0000-000000000000}"/>
          </ac:spMkLst>
        </pc:spChg>
      </pc:sldChg>
    </pc:docChg>
  </pc:docChgLst>
  <pc:docChgLst>
    <pc:chgData name="MITSUZAWA Shigenobu" userId="S::722940@jp.honda-ri.com::dea47e31-a259-4843-91ca-0f6173b4ded7" providerId="AD" clId="Web-{ABD2D9A6-6AE6-4DAE-7E6E-EB84A508C742}"/>
    <pc:docChg chg="delSld modSld">
      <pc:chgData name="MITSUZAWA Shigenobu" userId="S::722940@jp.honda-ri.com::dea47e31-a259-4843-91ca-0f6173b4ded7" providerId="AD" clId="Web-{ABD2D9A6-6AE6-4DAE-7E6E-EB84A508C742}" dt="2019-10-07T02:31:06.965" v="6"/>
      <pc:docMkLst>
        <pc:docMk/>
      </pc:docMkLst>
      <pc:sldChg chg="del">
        <pc:chgData name="MITSUZAWA Shigenobu" userId="S::722940@jp.honda-ri.com::dea47e31-a259-4843-91ca-0f6173b4ded7" providerId="AD" clId="Web-{ABD2D9A6-6AE6-4DAE-7E6E-EB84A508C742}" dt="2019-10-07T02:30:51.840" v="0"/>
        <pc:sldMkLst>
          <pc:docMk/>
          <pc:sldMk cId="2201234747" sldId="284"/>
        </pc:sldMkLst>
      </pc:sldChg>
      <pc:sldChg chg="del">
        <pc:chgData name="MITSUZAWA Shigenobu" userId="S::722940@jp.honda-ri.com::dea47e31-a259-4843-91ca-0f6173b4ded7" providerId="AD" clId="Web-{ABD2D9A6-6AE6-4DAE-7E6E-EB84A508C742}" dt="2019-10-07T02:30:52.809" v="1"/>
        <pc:sldMkLst>
          <pc:docMk/>
          <pc:sldMk cId="4282462745" sldId="285"/>
        </pc:sldMkLst>
      </pc:sldChg>
      <pc:sldChg chg="delSp modSp">
        <pc:chgData name="MITSUZAWA Shigenobu" userId="S::722940@jp.honda-ri.com::dea47e31-a259-4843-91ca-0f6173b4ded7" providerId="AD" clId="Web-{ABD2D9A6-6AE6-4DAE-7E6E-EB84A508C742}" dt="2019-10-07T02:31:06.965" v="6"/>
        <pc:sldMkLst>
          <pc:docMk/>
          <pc:sldMk cId="3602664236" sldId="288"/>
        </pc:sldMkLst>
        <pc:spChg chg="del mod">
          <ac:chgData name="MITSUZAWA Shigenobu" userId="S::722940@jp.honda-ri.com::dea47e31-a259-4843-91ca-0f6173b4ded7" providerId="AD" clId="Web-{ABD2D9A6-6AE6-4DAE-7E6E-EB84A508C742}" dt="2019-10-07T02:31:04.309" v="5"/>
          <ac:spMkLst>
            <pc:docMk/>
            <pc:sldMk cId="3602664236" sldId="288"/>
            <ac:spMk id="319" creationId="{00000000-0000-0000-0000-000000000000}"/>
          </ac:spMkLst>
        </pc:spChg>
        <pc:grpChg chg="del">
          <ac:chgData name="MITSUZAWA Shigenobu" userId="S::722940@jp.honda-ri.com::dea47e31-a259-4843-91ca-0f6173b4ded7" providerId="AD" clId="Web-{ABD2D9A6-6AE6-4DAE-7E6E-EB84A508C742}" dt="2019-10-07T02:31:06.965" v="6"/>
          <ac:grpSpMkLst>
            <pc:docMk/>
            <pc:sldMk cId="3602664236" sldId="288"/>
            <ac:grpSpMk id="26" creationId="{00000000-0000-0000-0000-000000000000}"/>
          </ac:grpSpMkLst>
        </pc:grpChg>
      </pc:sldChg>
    </pc:docChg>
  </pc:docChgLst>
  <pc:docChgLst>
    <pc:chgData name="SHINKAWA Satoru" userId="S::323329@jp.honda-ri.com::c45c76bf-e864-4554-8776-a99736ef45b7" providerId="AD" clId="Web-{5AC1333F-34DF-1AB0-D7D5-EB79C57C7BE8}"/>
    <pc:docChg chg="modSld">
      <pc:chgData name="SHINKAWA Satoru" userId="S::323329@jp.honda-ri.com::c45c76bf-e864-4554-8776-a99736ef45b7" providerId="AD" clId="Web-{5AC1333F-34DF-1AB0-D7D5-EB79C57C7BE8}" dt="2019-06-25T07:02:12.898" v="136" actId="20577"/>
      <pc:docMkLst>
        <pc:docMk/>
      </pc:docMkLst>
      <pc:sldChg chg="addSp delSp modSp">
        <pc:chgData name="SHINKAWA Satoru" userId="S::323329@jp.honda-ri.com::c45c76bf-e864-4554-8776-a99736ef45b7" providerId="AD" clId="Web-{5AC1333F-34DF-1AB0-D7D5-EB79C57C7BE8}" dt="2019-06-25T07:02:09.211" v="134" actId="20577"/>
        <pc:sldMkLst>
          <pc:docMk/>
          <pc:sldMk cId="2558221072" sldId="257"/>
        </pc:sldMkLst>
        <pc:spChg chg="del">
          <ac:chgData name="SHINKAWA Satoru" userId="S::323329@jp.honda-ri.com::c45c76bf-e864-4554-8776-a99736ef45b7" providerId="AD" clId="Web-{5AC1333F-34DF-1AB0-D7D5-EB79C57C7BE8}" dt="2019-06-25T06:48:36.381" v="3"/>
          <ac:spMkLst>
            <pc:docMk/>
            <pc:sldMk cId="2558221072" sldId="257"/>
            <ac:spMk id="3" creationId="{00000000-0000-0000-0000-000000000000}"/>
          </ac:spMkLst>
        </pc:spChg>
        <pc:spChg chg="del">
          <ac:chgData name="SHINKAWA Satoru" userId="S::323329@jp.honda-ri.com::c45c76bf-e864-4554-8776-a99736ef45b7" providerId="AD" clId="Web-{5AC1333F-34DF-1AB0-D7D5-EB79C57C7BE8}" dt="2019-06-25T06:48:32.584" v="2"/>
          <ac:spMkLst>
            <pc:docMk/>
            <pc:sldMk cId="2558221072" sldId="257"/>
            <ac:spMk id="5" creationId="{00000000-0000-0000-0000-000000000000}"/>
          </ac:spMkLst>
        </pc:spChg>
        <pc:spChg chg="mod">
          <ac:chgData name="SHINKAWA Satoru" userId="S::323329@jp.honda-ri.com::c45c76bf-e864-4554-8776-a99736ef45b7" providerId="AD" clId="Web-{5AC1333F-34DF-1AB0-D7D5-EB79C57C7BE8}" dt="2019-06-25T07:02:09.211" v="134" actId="20577"/>
          <ac:spMkLst>
            <pc:docMk/>
            <pc:sldMk cId="2558221072" sldId="257"/>
            <ac:spMk id="6" creationId="{00000000-0000-0000-0000-000000000000}"/>
          </ac:spMkLst>
        </pc:spChg>
        <pc:spChg chg="del mod">
          <ac:chgData name="SHINKAWA Satoru" userId="S::323329@jp.honda-ri.com::c45c76bf-e864-4554-8776-a99736ef45b7" providerId="AD" clId="Web-{5AC1333F-34DF-1AB0-D7D5-EB79C57C7BE8}" dt="2019-06-25T06:59:56.398" v="110"/>
          <ac:spMkLst>
            <pc:docMk/>
            <pc:sldMk cId="2558221072" sldId="257"/>
            <ac:spMk id="7" creationId="{00000000-0000-0000-0000-000000000000}"/>
          </ac:spMkLst>
        </pc:spChg>
        <pc:spChg chg="mod">
          <ac:chgData name="SHINKAWA Satoru" userId="S::323329@jp.honda-ri.com::c45c76bf-e864-4554-8776-a99736ef45b7" providerId="AD" clId="Web-{5AC1333F-34DF-1AB0-D7D5-EB79C57C7BE8}" dt="2019-06-25T07:00:46.320" v="115" actId="20577"/>
          <ac:spMkLst>
            <pc:docMk/>
            <pc:sldMk cId="2558221072" sldId="257"/>
            <ac:spMk id="11" creationId="{00000000-0000-0000-0000-000000000000}"/>
          </ac:spMkLst>
        </pc:spChg>
        <pc:spChg chg="add del mod">
          <ac:chgData name="SHINKAWA Satoru" userId="S::323329@jp.honda-ri.com::c45c76bf-e864-4554-8776-a99736ef45b7" providerId="AD" clId="Web-{5AC1333F-34DF-1AB0-D7D5-EB79C57C7BE8}" dt="2019-06-25T06:58:37.663" v="53"/>
          <ac:spMkLst>
            <pc:docMk/>
            <pc:sldMk cId="2558221072" sldId="257"/>
            <ac:spMk id="12" creationId="{579A91A5-0D28-4D65-B6B7-FA1B9BBC71ED}"/>
          </ac:spMkLst>
        </pc:spChg>
        <pc:picChg chg="mod">
          <ac:chgData name="SHINKAWA Satoru" userId="S::323329@jp.honda-ri.com::c45c76bf-e864-4554-8776-a99736ef45b7" providerId="AD" clId="Web-{5AC1333F-34DF-1AB0-D7D5-EB79C57C7BE8}" dt="2019-06-25T07:00:03.960" v="111" actId="1076"/>
          <ac:picMkLst>
            <pc:docMk/>
            <pc:sldMk cId="2558221072" sldId="257"/>
            <ac:picMk id="4" creationId="{00000000-0000-0000-0000-000000000000}"/>
          </ac:picMkLst>
        </pc:picChg>
      </pc:sldChg>
    </pc:docChg>
  </pc:docChgLst>
  <pc:docChgLst>
    <pc:chgData name="SHINKAWA Satoru" userId="S::323329@jp.honda-ri.com::c45c76bf-e864-4554-8776-a99736ef45b7" providerId="AD" clId="Web-{820B1BDD-8D69-AA17-B677-F0A7702F3FF8}"/>
    <pc:docChg chg="modSld">
      <pc:chgData name="SHINKAWA Satoru" userId="S::323329@jp.honda-ri.com::c45c76bf-e864-4554-8776-a99736ef45b7" providerId="AD" clId="Web-{820B1BDD-8D69-AA17-B677-F0A7702F3FF8}" dt="2019-06-21T06:30:19.085" v="2"/>
      <pc:docMkLst>
        <pc:docMk/>
      </pc:docMkLst>
      <pc:sldChg chg="addSp delSp modSp">
        <pc:chgData name="SHINKAWA Satoru" userId="S::323329@jp.honda-ri.com::c45c76bf-e864-4554-8776-a99736ef45b7" providerId="AD" clId="Web-{820B1BDD-8D69-AA17-B677-F0A7702F3FF8}" dt="2019-06-21T06:30:19.085" v="2"/>
        <pc:sldMkLst>
          <pc:docMk/>
          <pc:sldMk cId="658570852" sldId="272"/>
        </pc:sldMkLst>
        <pc:picChg chg="mod">
          <ac:chgData name="SHINKAWA Satoru" userId="S::323329@jp.honda-ri.com::c45c76bf-e864-4554-8776-a99736ef45b7" providerId="AD" clId="Web-{820B1BDD-8D69-AA17-B677-F0A7702F3FF8}" dt="2019-06-21T06:30:05.117" v="0" actId="1076"/>
          <ac:picMkLst>
            <pc:docMk/>
            <pc:sldMk cId="658570852" sldId="272"/>
            <ac:picMk id="4" creationId="{00000000-0000-0000-0000-000000000000}"/>
          </ac:picMkLst>
        </pc:picChg>
        <pc:picChg chg="add del mod">
          <ac:chgData name="SHINKAWA Satoru" userId="S::323329@jp.honda-ri.com::c45c76bf-e864-4554-8776-a99736ef45b7" providerId="AD" clId="Web-{820B1BDD-8D69-AA17-B677-F0A7702F3FF8}" dt="2019-06-21T06:30:19.085" v="2"/>
          <ac:picMkLst>
            <pc:docMk/>
            <pc:sldMk cId="658570852" sldId="272"/>
            <ac:picMk id="6" creationId="{021D95BB-54B5-45F5-8DD9-86C137F16BB8}"/>
          </ac:picMkLst>
        </pc:picChg>
      </pc:sldChg>
    </pc:docChg>
  </pc:docChgLst>
  <pc:docChgLst>
    <pc:chgData name="MITSUZAWA Shigenobu" userId="S::722940@jp.honda-ri.com::dea47e31-a259-4843-91ca-0f6173b4ded7" providerId="AD" clId="Web-{0027EA7B-7F24-0ABD-6537-DBADD8D8F587}"/>
    <pc:docChg chg="sldOrd">
      <pc:chgData name="MITSUZAWA Shigenobu" userId="S::722940@jp.honda-ri.com::dea47e31-a259-4843-91ca-0f6173b4ded7" providerId="AD" clId="Web-{0027EA7B-7F24-0ABD-6537-DBADD8D8F587}" dt="2019-10-07T02:34:20.464" v="1"/>
      <pc:docMkLst>
        <pc:docMk/>
      </pc:docMkLst>
      <pc:sldChg chg="ord">
        <pc:chgData name="MITSUZAWA Shigenobu" userId="S::722940@jp.honda-ri.com::dea47e31-a259-4843-91ca-0f6173b4ded7" providerId="AD" clId="Web-{0027EA7B-7F24-0ABD-6537-DBADD8D8F587}" dt="2019-10-07T02:33:43.635" v="0"/>
        <pc:sldMkLst>
          <pc:docMk/>
          <pc:sldMk cId="531892977" sldId="256"/>
        </pc:sldMkLst>
      </pc:sldChg>
      <pc:sldChg chg="ord">
        <pc:chgData name="MITSUZAWA Shigenobu" userId="S::722940@jp.honda-ri.com::dea47e31-a259-4843-91ca-0f6173b4ded7" providerId="AD" clId="Web-{0027EA7B-7F24-0ABD-6537-DBADD8D8F587}" dt="2019-10-07T02:34:20.464" v="1"/>
        <pc:sldMkLst>
          <pc:docMk/>
          <pc:sldMk cId="4232154430" sldId="282"/>
        </pc:sldMkLst>
      </pc:sldChg>
    </pc:docChg>
  </pc:docChgLst>
  <pc:docChgLst>
    <pc:chgData name="SHINKAWA Satoru" userId="S::323329@jp.honda-ri.com::c45c76bf-e864-4554-8776-a99736ef45b7" providerId="AD" clId="Web-{68EEA754-8403-A4C4-099D-4EAAAE87E0E3}"/>
    <pc:docChg chg="modSld">
      <pc:chgData name="SHINKAWA Satoru" userId="S::323329@jp.honda-ri.com::c45c76bf-e864-4554-8776-a99736ef45b7" providerId="AD" clId="Web-{68EEA754-8403-A4C4-099D-4EAAAE87E0E3}" dt="2019-06-18T07:45:44.381" v="3" actId="20577"/>
      <pc:docMkLst>
        <pc:docMk/>
      </pc:docMkLst>
      <pc:sldChg chg="modSp">
        <pc:chgData name="SHINKAWA Satoru" userId="S::323329@jp.honda-ri.com::c45c76bf-e864-4554-8776-a99736ef45b7" providerId="AD" clId="Web-{68EEA754-8403-A4C4-099D-4EAAAE87E0E3}" dt="2019-06-18T07:45:44.381" v="2" actId="20577"/>
        <pc:sldMkLst>
          <pc:docMk/>
          <pc:sldMk cId="690213262" sldId="278"/>
        </pc:sldMkLst>
        <pc:spChg chg="mod">
          <ac:chgData name="SHINKAWA Satoru" userId="S::323329@jp.honda-ri.com::c45c76bf-e864-4554-8776-a99736ef45b7" providerId="AD" clId="Web-{68EEA754-8403-A4C4-099D-4EAAAE87E0E3}" dt="2019-06-18T07:45:44.381" v="2" actId="20577"/>
          <ac:spMkLst>
            <pc:docMk/>
            <pc:sldMk cId="690213262" sldId="278"/>
            <ac:spMk id="6" creationId="{00000000-0000-0000-0000-000000000000}"/>
          </ac:spMkLst>
        </pc:spChg>
      </pc:sldChg>
    </pc:docChg>
  </pc:docChgLst>
  <pc:docChgLst>
    <pc:chgData name="SHINKAWA Satoru" userId="S::323329@jp.honda-ri.com::c45c76bf-e864-4554-8776-a99736ef45b7" providerId="AD" clId="Web-{B1227DA5-5ACA-AFBA-7F14-27659559053A}"/>
    <pc:docChg chg="modSld">
      <pc:chgData name="SHINKAWA Satoru" userId="S::323329@jp.honda-ri.com::c45c76bf-e864-4554-8776-a99736ef45b7" providerId="AD" clId="Web-{B1227DA5-5ACA-AFBA-7F14-27659559053A}" dt="2019-09-06T04:20:17.706" v="2"/>
      <pc:docMkLst>
        <pc:docMk/>
      </pc:docMkLst>
      <pc:sldChg chg="addSp delSp modSp">
        <pc:chgData name="SHINKAWA Satoru" userId="S::323329@jp.honda-ri.com::c45c76bf-e864-4554-8776-a99736ef45b7" providerId="AD" clId="Web-{B1227DA5-5ACA-AFBA-7F14-27659559053A}" dt="2019-09-06T04:20:17.706" v="2"/>
        <pc:sldMkLst>
          <pc:docMk/>
          <pc:sldMk cId="940661961" sldId="280"/>
        </pc:sldMkLst>
        <pc:spChg chg="add del mod">
          <ac:chgData name="SHINKAWA Satoru" userId="S::323329@jp.honda-ri.com::c45c76bf-e864-4554-8776-a99736ef45b7" providerId="AD" clId="Web-{B1227DA5-5ACA-AFBA-7F14-27659559053A}" dt="2019-09-06T04:20:17.706" v="2"/>
          <ac:spMkLst>
            <pc:docMk/>
            <pc:sldMk cId="940661961" sldId="280"/>
            <ac:spMk id="69" creationId="{2541848E-E721-4080-B2C8-B6B903E3882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67251C-7B49-4269-996D-A0D85004B2B5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34E2D2-4AA9-40B7-860D-98CB78C75D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382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253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925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500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454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414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4938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4610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1857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7754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197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49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528131-800C-4B62-A791-C0CAF6C7EDC9}" type="datetimeFigureOut">
              <a:rPr kumimoji="1" lang="ja-JP" altLang="en-US" smtClean="0"/>
              <a:t>2019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756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21910" y="-22086"/>
            <a:ext cx="14766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cs typeface="Helvetica" pitchFamily="34" charset="0"/>
              </a:rPr>
              <a:t>FIGURE </a:t>
            </a:r>
            <a:r>
              <a:rPr kumimoji="1" lang="en-US" altLang="ja-JP" sz="2400" dirty="0" smtClean="0">
                <a:cs typeface="Helvetica" pitchFamily="34" charset="0"/>
              </a:rPr>
              <a:t>S2</a:t>
            </a:r>
            <a:endParaRPr kumimoji="1" lang="ja-JP" altLang="en-US" sz="2400" dirty="0">
              <a:cs typeface="Helvetica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54107" y="385306"/>
            <a:ext cx="4572000" cy="52322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sz="1400" kern="0" dirty="0">
                <a:ea typeface="游明朝" panose="02020400000000000000" pitchFamily="18" charset="-128"/>
                <a:cs typeface="Times New Roman" panose="02020603050405020304" pitchFamily="18" charset="0"/>
              </a:rPr>
              <a:t>Gene name : β-glucosidase(BGL)</a:t>
            </a:r>
            <a:endParaRPr lang="ja-JP" altLang="ja-JP" sz="1400" kern="100" dirty="0"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kern="0" dirty="0">
                <a:ea typeface="游明朝" panose="02020400000000000000" pitchFamily="18" charset="-128"/>
                <a:cs typeface="Times New Roman" panose="02020603050405020304" pitchFamily="18" charset="0"/>
              </a:rPr>
              <a:t>Sequence length : 2442 base pairs</a:t>
            </a:r>
            <a:endParaRPr lang="ja-JP" altLang="ja-JP" sz="1400" kern="100" dirty="0">
              <a:effectLst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1" name="図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526" y="914984"/>
            <a:ext cx="4479162" cy="5855011"/>
          </a:xfrm>
          <a:prstGeom prst="rect">
            <a:avLst/>
          </a:prstGeom>
        </p:spPr>
      </p:pic>
      <p:sp>
        <p:nvSpPr>
          <p:cNvPr id="12" name="正方形/長方形 11"/>
          <p:cNvSpPr/>
          <p:nvPr/>
        </p:nvSpPr>
        <p:spPr>
          <a:xfrm>
            <a:off x="4810046" y="385306"/>
            <a:ext cx="263362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kern="0" dirty="0">
                <a:ea typeface="游明朝" panose="02020400000000000000" pitchFamily="18" charset="-128"/>
                <a:cs typeface="Times New Roman" panose="02020603050405020304" pitchFamily="18" charset="0"/>
              </a:rPr>
              <a:t>Gene name : EX</a:t>
            </a:r>
            <a:endParaRPr lang="ja-JP" altLang="ja-JP" sz="1400" kern="100" dirty="0"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kern="0" dirty="0">
                <a:ea typeface="游明朝" panose="02020400000000000000" pitchFamily="18" charset="-128"/>
                <a:cs typeface="Times New Roman" panose="02020603050405020304" pitchFamily="18" charset="0"/>
              </a:rPr>
              <a:t>Sequence length : 990 base pairs</a:t>
            </a:r>
            <a:endParaRPr lang="ja-JP" altLang="ja-JP" sz="1400" kern="100" dirty="0">
              <a:effectLst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3" name="図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47566" y="885855"/>
            <a:ext cx="4138733" cy="36785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6271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0</TotalTime>
  <Words>23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游ゴシック</vt:lpstr>
      <vt:lpstr>游ゴシック Light</vt:lpstr>
      <vt:lpstr>游明朝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KAWA Satoru</dc:creator>
  <cp:lastModifiedBy>SHINKAWA Satoru</cp:lastModifiedBy>
  <cp:revision>83</cp:revision>
  <dcterms:created xsi:type="dcterms:W3CDTF">2019-02-15T05:38:43Z</dcterms:created>
  <dcterms:modified xsi:type="dcterms:W3CDTF">2019-11-08T05:46:27Z</dcterms:modified>
</cp:coreProperties>
</file>